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9" d="100"/>
          <a:sy n="69" d="100"/>
        </p:scale>
        <p:origin x="1404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9A25C-ADC4-4C47-A2E6-B373C9DDC8CA}" type="datetimeFigureOut">
              <a:rPr lang="en-US" smtClean="0"/>
              <a:t>2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DDF5F-6FB9-BE4C-889C-D28830A0C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6199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9A25C-ADC4-4C47-A2E6-B373C9DDC8CA}" type="datetimeFigureOut">
              <a:rPr lang="en-US" smtClean="0"/>
              <a:t>2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DDF5F-6FB9-BE4C-889C-D28830A0C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1723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9A25C-ADC4-4C47-A2E6-B373C9DDC8CA}" type="datetimeFigureOut">
              <a:rPr lang="en-US" smtClean="0"/>
              <a:t>2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DDF5F-6FB9-BE4C-889C-D28830A0C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993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9A25C-ADC4-4C47-A2E6-B373C9DDC8CA}" type="datetimeFigureOut">
              <a:rPr lang="en-US" smtClean="0"/>
              <a:t>2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DDF5F-6FB9-BE4C-889C-D28830A0C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264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9A25C-ADC4-4C47-A2E6-B373C9DDC8CA}" type="datetimeFigureOut">
              <a:rPr lang="en-US" smtClean="0"/>
              <a:t>2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DDF5F-6FB9-BE4C-889C-D28830A0C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115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9A25C-ADC4-4C47-A2E6-B373C9DDC8CA}" type="datetimeFigureOut">
              <a:rPr lang="en-US" smtClean="0"/>
              <a:t>2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DDF5F-6FB9-BE4C-889C-D28830A0C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381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9A25C-ADC4-4C47-A2E6-B373C9DDC8CA}" type="datetimeFigureOut">
              <a:rPr lang="en-US" smtClean="0"/>
              <a:t>2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DDF5F-6FB9-BE4C-889C-D28830A0C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371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9A25C-ADC4-4C47-A2E6-B373C9DDC8CA}" type="datetimeFigureOut">
              <a:rPr lang="en-US" smtClean="0"/>
              <a:t>2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DDF5F-6FB9-BE4C-889C-D28830A0C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397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9A25C-ADC4-4C47-A2E6-B373C9DDC8CA}" type="datetimeFigureOut">
              <a:rPr lang="en-US" smtClean="0"/>
              <a:t>2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DDF5F-6FB9-BE4C-889C-D28830A0C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487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9A25C-ADC4-4C47-A2E6-B373C9DDC8CA}" type="datetimeFigureOut">
              <a:rPr lang="en-US" smtClean="0"/>
              <a:t>2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DDF5F-6FB9-BE4C-889C-D28830A0C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700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9A25C-ADC4-4C47-A2E6-B373C9DDC8CA}" type="datetimeFigureOut">
              <a:rPr lang="en-US" smtClean="0"/>
              <a:t>2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EDDF5F-6FB9-BE4C-889C-D28830A0C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447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A9A25C-ADC4-4C47-A2E6-B373C9DDC8CA}" type="datetimeFigureOut">
              <a:rPr lang="en-US" smtClean="0"/>
              <a:t>2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EDDF5F-6FB9-BE4C-889C-D28830A0C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273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27887" t="6649" b="51395"/>
          <a:stretch/>
        </p:blipFill>
        <p:spPr>
          <a:xfrm>
            <a:off x="617615" y="915024"/>
            <a:ext cx="4091117" cy="276372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68080" y="59745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A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-795233" y="2151119"/>
            <a:ext cx="2442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HER2 Fold Change Expression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403646" y="3723815"/>
            <a:ext cx="101500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/>
                <a:cs typeface="Arial"/>
              </a:rPr>
              <a:t>Normal Lung</a:t>
            </a:r>
            <a:endParaRPr lang="en-US" sz="1050" b="1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244274" y="3723815"/>
            <a:ext cx="6030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/>
                <a:cs typeface="Arial"/>
              </a:rPr>
              <a:t>Tumor</a:t>
            </a:r>
            <a:endParaRPr lang="en-US" sz="1050" b="1" dirty="0">
              <a:latin typeface="Arial"/>
              <a:cs typeface="Arial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l="28814" t="7061" b="50729"/>
          <a:stretch/>
        </p:blipFill>
        <p:spPr>
          <a:xfrm>
            <a:off x="5112776" y="1068558"/>
            <a:ext cx="4010354" cy="2610187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 rot="16200000">
            <a:off x="3891717" y="2151120"/>
            <a:ext cx="2442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HER2 Fold Change Expression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720686" y="3834213"/>
            <a:ext cx="101500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/>
                <a:cs typeface="Arial"/>
              </a:rPr>
              <a:t>Normal Lung</a:t>
            </a:r>
            <a:endParaRPr lang="en-US" sz="1050" b="1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780072" y="3753422"/>
            <a:ext cx="117211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 smtClean="0">
                <a:latin typeface="Arial"/>
                <a:cs typeface="Arial"/>
              </a:rPr>
              <a:t>Tumor</a:t>
            </a:r>
            <a:endParaRPr lang="en-US" sz="1050" b="1" dirty="0" smtClean="0">
              <a:latin typeface="Arial"/>
              <a:cs typeface="Arial"/>
            </a:endParaRPr>
          </a:p>
          <a:p>
            <a:pPr algn="ctr"/>
            <a:r>
              <a:rPr lang="en-US" sz="1050" b="1" i="1" dirty="0" smtClean="0">
                <a:latin typeface="Arial"/>
                <a:cs typeface="Arial"/>
              </a:rPr>
              <a:t>HER2</a:t>
            </a:r>
            <a:r>
              <a:rPr lang="en-US" sz="1050" b="1" dirty="0" smtClean="0">
                <a:latin typeface="Arial"/>
                <a:cs typeface="Arial"/>
              </a:rPr>
              <a:t>-wild-type</a:t>
            </a:r>
            <a:endParaRPr lang="en-US" sz="1050" b="1" baseline="30000" dirty="0">
              <a:latin typeface="Arial"/>
              <a:cs typeface="Arial"/>
            </a:endParaRPr>
          </a:p>
          <a:p>
            <a:pPr algn="ctr"/>
            <a:endParaRPr lang="en-US" sz="1050" b="1" baseline="300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7953669" y="3753422"/>
            <a:ext cx="103105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 smtClean="0">
                <a:latin typeface="Arial"/>
                <a:cs typeface="Arial"/>
              </a:rPr>
              <a:t>Tumor</a:t>
            </a:r>
            <a:endParaRPr lang="en-US" sz="1050" b="1" dirty="0" smtClean="0">
              <a:latin typeface="Arial"/>
              <a:cs typeface="Arial"/>
            </a:endParaRPr>
          </a:p>
          <a:p>
            <a:pPr algn="ctr"/>
            <a:r>
              <a:rPr lang="en-US" sz="1050" b="1" i="1" dirty="0" smtClean="0">
                <a:latin typeface="Arial"/>
                <a:cs typeface="Arial"/>
              </a:rPr>
              <a:t>HER2</a:t>
            </a:r>
            <a:r>
              <a:rPr lang="en-US" sz="1050" b="1" dirty="0">
                <a:latin typeface="Arial"/>
                <a:cs typeface="Arial"/>
              </a:rPr>
              <a:t>-</a:t>
            </a:r>
            <a:r>
              <a:rPr lang="en-US" sz="1050" b="1" dirty="0" smtClean="0">
                <a:latin typeface="Arial"/>
                <a:cs typeface="Arial"/>
              </a:rPr>
              <a:t>Mutant</a:t>
            </a:r>
            <a:endParaRPr lang="en-US" sz="1050" b="1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146671" y="59745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B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26634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9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ofile</dc:creator>
  <cp:lastModifiedBy>William Hendricks</cp:lastModifiedBy>
  <cp:revision>8</cp:revision>
  <dcterms:created xsi:type="dcterms:W3CDTF">2019-02-13T03:02:06Z</dcterms:created>
  <dcterms:modified xsi:type="dcterms:W3CDTF">2019-02-18T16:22:57Z</dcterms:modified>
</cp:coreProperties>
</file>